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118"/>
  </p:normalViewPr>
  <p:slideViewPr>
    <p:cSldViewPr snapToGrid="0">
      <p:cViewPr varScale="1">
        <p:scale>
          <a:sx n="95" d="100"/>
          <a:sy n="95" d="100"/>
        </p:scale>
        <p:origin x="68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2FF5CB6-E112-645E-0CE4-12386D48DA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E7F7553-4577-4594-318E-BDD4C1E91A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1E83E6B-F712-2ACD-A619-08D5F8AF1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B20DAE0-693A-8769-563F-D4B627F52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878E363-4EBD-1E7C-4F0F-7CDF4C262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30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BF7CE73-D168-EFF0-EFC5-C3B3D43FF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5BC6E2A-A056-FB01-6318-82FE4D80A9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FF58BA5-1D96-05D9-0DC9-32F71A969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8E6366B-E163-414C-23F8-8A867D0C6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2EAC34-334F-6943-C24E-5F7506889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7044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FAA856B-CEE1-B958-E318-BDA7E660C3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90D144E-FA5A-0BA1-D287-0CDF31AC3A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43FFCF0-6F15-F724-2188-B12DCA9EE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39BFEC2-4FF1-DB5A-549A-5414C2E1B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52B6DD-E6EE-A698-EF69-81DFE942B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2198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F263B35-902C-1664-BAC1-D291CF6385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8403E41-4190-70A1-5677-049A700934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A9A002-69A2-D5DE-FC0E-59DAD04BA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6D0A83D-664E-0A27-0155-63740BA6C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50AE4C0-8D53-E129-16C3-E2A3A3543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901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602C258-74BF-42D3-B390-ACA79A5271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9B25850-5210-FC4E-8DBE-83472F08E8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0681B83-4704-E076-159D-42AD29395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80330A0-D76E-2288-6757-A228BB14E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2AB5698-856E-C97D-5C83-8957F322F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582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EC26D0E-177A-7923-E94A-291D21C66A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9E191A4-B5C8-043C-842D-B6F9EA3F9C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B68363-8E36-D27C-56ED-C9985DA47F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82B835-61E5-8235-2BCB-CC66E3BE7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2002D24-6DAA-9557-8F71-47331FB0A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4426822-8598-3E25-2259-543E1D12E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5734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58FB635-75FC-5A9A-1C50-91C4E0329E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3CA5960-25FA-56E8-108B-5F7273460C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31EF359-3794-F2E2-71C6-4A88A52C4B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F00FEEC-B3CF-DD45-BDAE-14B14D9C81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6451DAC-25CE-07D2-EAE5-798DF25ECA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913688A-ABAC-6B45-456A-E2E9FEACA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865EC0D-FBDB-C4D4-1ECE-F89D0BBE9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00EA390-6AE4-43B0-6A01-1D85CAB93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2915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46862C-2A0A-2384-615F-044010A707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FECB5E9-40AB-4ED4-CF19-EDE48815C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8FED233-5AF1-38D4-97E1-D7EED078E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89B71C5-2230-267F-AAD6-00A4A0FA6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5867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8589279-395B-D62E-9819-6DEAD5364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8F415C8-EFAF-6FEB-E005-F430CA499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EA5F9A1-6EE0-6489-7174-A171DF4E4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8474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10A008-D2DE-1C14-4B71-4C7C435C3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0AC15FF-30B7-9DDE-C590-304A7776AE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A0E5F3C-A726-2210-78E3-93AF904812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FE532DC-5E62-1E12-FA67-52B161CED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87629D1-CDBF-57D4-9422-2097386D9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9693F41-8B23-3AD8-0C30-D81983CFE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170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C3E791-CACB-611F-C5B9-30D5C84650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485201E-1705-7FB2-07C5-12F4B8E94A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7E4BDDD-127D-BDE5-23CC-7B16547D32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6BC6571-9AE2-34AA-42BC-2A3A14115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2238469-A514-C0E9-79CA-39FE696B6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41B3C2F-58E6-C1B7-42FE-428EB9AA2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5636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2E4450F-44E9-7528-B7C7-66ECE8D00E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6B247F6-06D3-4112-09D9-F9591BA2DC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D9A7918-5019-C199-DDFD-C3F7A06691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AE76F-29D8-AD47-A786-D7F9105BB350}" type="datetimeFigureOut">
              <a:rPr lang="fr-FR" smtClean="0"/>
              <a:t>09/05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2BD7A0E-A440-FF8A-72AC-7C721C94F5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032887E-F9CA-A80F-B8F3-C09066279F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2B1EA-5EAD-FD44-BA87-652F3E496F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5730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diagramme, schématique&#10;&#10;Description générée automatiquement">
            <a:extLst>
              <a:ext uri="{FF2B5EF4-FFF2-40B4-BE49-F238E27FC236}">
                <a16:creationId xmlns:a16="http://schemas.microsoft.com/office/drawing/2014/main" id="{96F04DBF-7340-A858-E343-3E4C6F98D2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5535" y="0"/>
            <a:ext cx="3973071" cy="685800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39311FDF-288F-614E-ACFB-92613941DEB6}"/>
              </a:ext>
            </a:extLst>
          </p:cNvPr>
          <p:cNvSpPr txBox="1"/>
          <p:nvPr/>
        </p:nvSpPr>
        <p:spPr>
          <a:xfrm>
            <a:off x="-1" y="779493"/>
            <a:ext cx="379207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Classification and enrichment of the differentially expressed genes in a) KEGG and b) GO databases.</a:t>
            </a:r>
            <a:endParaRPr lang="fr-FR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426F3E9B-3136-53CB-A260-5AB5349B36EA}"/>
              </a:ext>
            </a:extLst>
          </p:cNvPr>
          <p:cNvSpPr txBox="1"/>
          <p:nvPr/>
        </p:nvSpPr>
        <p:spPr>
          <a:xfrm>
            <a:off x="5069540" y="259540"/>
            <a:ext cx="15508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0438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3D860B86-D2CE-A35C-25DE-7D468F5642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8961" y="272554"/>
            <a:ext cx="7772400" cy="6585446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6C9D3AC1-C5DA-CB78-4000-D520DDEBEBC4}"/>
              </a:ext>
            </a:extLst>
          </p:cNvPr>
          <p:cNvSpPr txBox="1"/>
          <p:nvPr/>
        </p:nvSpPr>
        <p:spPr>
          <a:xfrm>
            <a:off x="2770093" y="272554"/>
            <a:ext cx="15508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97443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4</Words>
  <Application>Microsoft Macintosh PowerPoint</Application>
  <PresentationFormat>Grand écran</PresentationFormat>
  <Paragraphs>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ffice</dc:creator>
  <cp:lastModifiedBy>office</cp:lastModifiedBy>
  <cp:revision>1</cp:revision>
  <dcterms:created xsi:type="dcterms:W3CDTF">2023-05-09T18:37:50Z</dcterms:created>
  <dcterms:modified xsi:type="dcterms:W3CDTF">2023-05-09T18:41:44Z</dcterms:modified>
</cp:coreProperties>
</file>